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1"/>
    <p:restoredTop sz="96197"/>
  </p:normalViewPr>
  <p:slideViewPr>
    <p:cSldViewPr snapToGrid="0" snapToObjects="1">
      <p:cViewPr varScale="1">
        <p:scale>
          <a:sx n="90" d="100"/>
          <a:sy n="90" d="100"/>
        </p:scale>
        <p:origin x="232" y="9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1850A0-AF75-8C61-AB60-B04918BBAEE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C6264B6-DBDA-B943-8A17-D46A6E4843C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54C989-5011-4DE5-8557-98D19764D0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432CB1-0B04-864E-B73B-401C1EDDD612}" type="datetimeFigureOut">
              <a:rPr lang="en-US" smtClean="0"/>
              <a:t>7/2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83F629-B6DC-0463-9676-ECEF097963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F83568-B32F-1474-F6B6-C2BF23AF8C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FBB59-E690-B344-9904-2B1278376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73705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40FD95-25AD-1678-D795-688601959C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FCB3B5C-DF9C-D429-C2E7-AFC838C5ABF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F51F37-2B92-3E03-96A5-9B876DD117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432CB1-0B04-864E-B73B-401C1EDDD612}" type="datetimeFigureOut">
              <a:rPr lang="en-US" smtClean="0"/>
              <a:t>7/2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5FEDD8-2A57-1753-7042-9BF8C04A9C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31A2F0-E16B-F940-9EBE-896C01CE62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FBB59-E690-B344-9904-2B1278376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40980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4D9F28C-B835-73A7-EA06-5AF404C9AA9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9892EB5-6AE1-97E8-C763-FE5BA4AB128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6F1A6C-FEAB-8CC8-372D-5BBF177635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432CB1-0B04-864E-B73B-401C1EDDD612}" type="datetimeFigureOut">
              <a:rPr lang="en-US" smtClean="0"/>
              <a:t>7/2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6BF751-BA02-1215-9EE8-FD3AC9D889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C8A979-3AA1-10B0-95BD-1A1FB4A386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FBB59-E690-B344-9904-2B1278376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77451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B462DC-501B-4764-7FC3-C2E273AAB9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238A281-F82F-A509-A635-44E8C3D0B5A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4AE7756-E4EA-12BE-0B6B-27C46FF146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432CB1-0B04-864E-B73B-401C1EDDD612}" type="datetimeFigureOut">
              <a:rPr lang="en-US" smtClean="0"/>
              <a:t>7/2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E09063-BD59-8326-B069-333C4754DE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BC3684-6BFF-CF3D-1701-16CDE3EC3C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FBB59-E690-B344-9904-2B1278376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15437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E6D5DE-72B8-4558-46DF-13E188ECAE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D49B934-2B67-EF79-28A7-6A1CB7F3B0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B3EAD2-9228-72C9-BC95-FD6E789936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432CB1-0B04-864E-B73B-401C1EDDD612}" type="datetimeFigureOut">
              <a:rPr lang="en-US" smtClean="0"/>
              <a:t>7/2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78E149-E560-ADFC-1F4A-083BA5D9AD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99F7A2-266F-4BCC-1166-E94A0EC9CA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FBB59-E690-B344-9904-2B1278376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6261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5A1372-8967-654B-16DA-81DE05F5D0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761F4D0-8590-E3E3-298A-40E75CBFC82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C05F20E-119A-B07C-7232-173AB72AF92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7E8202D-3950-8EBC-C040-4E2D68657B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432CB1-0B04-864E-B73B-401C1EDDD612}" type="datetimeFigureOut">
              <a:rPr lang="en-US" smtClean="0"/>
              <a:t>7/2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E1CCA50-9CCD-7831-5121-460D7FC139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75CD0E4-24CE-25A9-98F7-C3E0BE7147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FBB59-E690-B344-9904-2B1278376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29129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98B6C3-ED7A-79F5-0CCA-FFC784AC02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17F3016-4871-646A-520E-09D5D54F72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48F6DDB-5B62-7BD5-EA59-87B402C7395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96242AC-A933-7237-0D08-0D40A1DE206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BDB5888-B65E-EF12-6442-EAE95BACB70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F06E520-A60C-DCAA-3564-F6A02A4E61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432CB1-0B04-864E-B73B-401C1EDDD612}" type="datetimeFigureOut">
              <a:rPr lang="en-US" smtClean="0"/>
              <a:t>7/21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5EC9442-168F-48F8-4131-D37053BDE2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50BA06C-189E-A83C-6181-3A71EB1E05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FBB59-E690-B344-9904-2B1278376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2378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0E937D-29A2-C2F0-24D2-4776BCEDC9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E707158-9B4E-20E8-AE05-2B4AF3F00E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432CB1-0B04-864E-B73B-401C1EDDD612}" type="datetimeFigureOut">
              <a:rPr lang="en-US" smtClean="0"/>
              <a:t>7/21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5BF5B82-44DD-3946-9E58-712FCAC92D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141FBA0-9211-218D-2E8D-C74131D3B5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FBB59-E690-B344-9904-2B1278376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52725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1BE854F-594C-62BC-DC6A-B160258557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432CB1-0B04-864E-B73B-401C1EDDD612}" type="datetimeFigureOut">
              <a:rPr lang="en-US" smtClean="0"/>
              <a:t>7/21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A64A84E-95BE-68EE-8D2F-2B133BFC54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37966F1-5A53-1C31-98BE-DF06A94E84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FBB59-E690-B344-9904-2B1278376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76210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F49871-A66E-0F59-E8F8-8129332C7E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64E7ECA-2B75-3706-11EE-48BBBEC6209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83C27AC-3D4F-156C-9DAD-A65B721AB8A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1036E8C-9FC8-FFA6-7A13-391ED4B102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432CB1-0B04-864E-B73B-401C1EDDD612}" type="datetimeFigureOut">
              <a:rPr lang="en-US" smtClean="0"/>
              <a:t>7/2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922A958-5096-6D43-D841-C51AF3D360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B28B5FC-9425-25F5-1985-CBAC386F26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FBB59-E690-B344-9904-2B1278376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44661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A43165-0619-3B69-B3BC-9AD86A11E5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E1E69EB-4716-9099-4ED6-BD8A4EFDF74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4B66EAF-656C-DB02-9537-5C91F4DDE52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6AAA4D8-AB33-44E2-211F-C66113925D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432CB1-0B04-864E-B73B-401C1EDDD612}" type="datetimeFigureOut">
              <a:rPr lang="en-US" smtClean="0"/>
              <a:t>7/2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591F3D1-39FD-ECFB-2D2F-18EEB36E55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57D567F-EC6D-3E04-7E07-AE45586A74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FBB59-E690-B344-9904-2B1278376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58003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F0A1A82-E629-5EC3-7285-1CAE8FFE46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0DA0210-BDEE-3A98-4A88-1423715765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260E69-1A4A-4176-71F6-47ABB0306E0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432CB1-0B04-864E-B73B-401C1EDDD612}" type="datetimeFigureOut">
              <a:rPr lang="en-US" smtClean="0"/>
              <a:t>7/2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EADCFD-F103-8606-1DC7-C636CD1114B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1CBB72-ADD4-27F7-EAEB-9D46DC0B0D0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1FBB59-E690-B344-9904-2B1278376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53766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2.jpeg"/><Relationship Id="rId7" Type="http://schemas.openxmlformats.org/officeDocument/2006/relationships/image" Target="../media/image5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microsoft.com/office/2007/relationships/hdphoto" Target="../media/hdphoto1.wdp"/><Relationship Id="rId10" Type="http://schemas.openxmlformats.org/officeDocument/2006/relationships/image" Target="../media/image8.jpeg"/><Relationship Id="rId4" Type="http://schemas.openxmlformats.org/officeDocument/2006/relationships/image" Target="../media/image3.png"/><Relationship Id="rId9" Type="http://schemas.openxmlformats.org/officeDocument/2006/relationships/image" Target="../media/image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A66275C8-2881-B4B4-9FF3-4A09C9AB9D67}"/>
              </a:ext>
            </a:extLst>
          </p:cNvPr>
          <p:cNvSpPr/>
          <p:nvPr/>
        </p:nvSpPr>
        <p:spPr>
          <a:xfrm>
            <a:off x="14673" y="6312311"/>
            <a:ext cx="1620452" cy="3706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8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FD618113-C237-B401-D122-A822BE6E508F}"/>
              </a:ext>
            </a:extLst>
          </p:cNvPr>
          <p:cNvPicPr>
            <a:picLocks noChangeAspect="1"/>
          </p:cNvPicPr>
          <p:nvPr/>
        </p:nvPicPr>
        <p:blipFill>
          <a:blip r:embed="rId2">
            <a:lum bright="-2000"/>
          </a:blip>
          <a:stretch>
            <a:fillRect/>
          </a:stretch>
        </p:blipFill>
        <p:spPr>
          <a:xfrm>
            <a:off x="1072447" y="691608"/>
            <a:ext cx="1434316" cy="152213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4A638BB4-8D31-849E-9C69-3E6EC7C1F531}"/>
              </a:ext>
            </a:extLst>
          </p:cNvPr>
          <p:cNvPicPr>
            <a:picLocks noChangeAspect="1"/>
          </p:cNvPicPr>
          <p:nvPr/>
        </p:nvPicPr>
        <p:blipFill>
          <a:blip r:embed="rId3">
            <a:lum bright="-8000"/>
          </a:blip>
          <a:stretch>
            <a:fillRect/>
          </a:stretch>
        </p:blipFill>
        <p:spPr>
          <a:xfrm>
            <a:off x="2675187" y="691608"/>
            <a:ext cx="1434316" cy="152728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52E79BA3-5EEB-8BA4-4D12-FBD4C80655F3}"/>
              </a:ext>
            </a:extLst>
          </p:cNvPr>
          <p:cNvSpPr txBox="1"/>
          <p:nvPr/>
        </p:nvSpPr>
        <p:spPr>
          <a:xfrm>
            <a:off x="1972299" y="-14288"/>
            <a:ext cx="371302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a</a:t>
            </a:r>
            <a:endParaRPr lang="en-US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6BA3842-C312-CA4B-0F61-9587A253F5F7}"/>
              </a:ext>
            </a:extLst>
          </p:cNvPr>
          <p:cNvSpPr txBox="1"/>
          <p:nvPr/>
        </p:nvSpPr>
        <p:spPr>
          <a:xfrm>
            <a:off x="1263175" y="298068"/>
            <a:ext cx="96713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RUNX1</a:t>
            </a:r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B4CFFC7-AC93-C6FC-9170-34FBCFB5E814}"/>
              </a:ext>
            </a:extLst>
          </p:cNvPr>
          <p:cNvSpPr txBox="1"/>
          <p:nvPr/>
        </p:nvSpPr>
        <p:spPr>
          <a:xfrm>
            <a:off x="2894491" y="298068"/>
            <a:ext cx="107743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en-US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9575AEF-3473-88CC-20CE-A1CA6BE15477}"/>
              </a:ext>
            </a:extLst>
          </p:cNvPr>
          <p:cNvSpPr txBox="1"/>
          <p:nvPr/>
        </p:nvSpPr>
        <p:spPr>
          <a:xfrm>
            <a:off x="8601694" y="0"/>
            <a:ext cx="371302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b</a:t>
            </a:r>
            <a:endParaRPr lang="en-US" dirty="0"/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BAB682BF-43C1-0B1C-7DE6-7945812A3CE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100000"/>
                    </a14:imgEffect>
                    <a14:imgEffect>
                      <a14:brightnessContrast bright="-4000" contrast="23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9261707" y="676936"/>
            <a:ext cx="1434316" cy="152213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D35A937E-2738-51CC-E776-96C0A43524C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736334" y="676936"/>
            <a:ext cx="1414718" cy="152213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E9E4C06E-857D-F20C-E8F0-C97D52DA851F}"/>
              </a:ext>
            </a:extLst>
          </p:cNvPr>
          <p:cNvSpPr txBox="1"/>
          <p:nvPr/>
        </p:nvSpPr>
        <p:spPr>
          <a:xfrm>
            <a:off x="7882761" y="283395"/>
            <a:ext cx="96713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RUNX1</a:t>
            </a:r>
            <a:endParaRPr lang="en-US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3F15153-0FAC-E4CF-5062-0FAA581AE972}"/>
              </a:ext>
            </a:extLst>
          </p:cNvPr>
          <p:cNvSpPr txBox="1"/>
          <p:nvPr/>
        </p:nvSpPr>
        <p:spPr>
          <a:xfrm>
            <a:off x="9514077" y="283395"/>
            <a:ext cx="107743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en-US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3FB7170-ED8A-9F80-FF99-67BDBF613000}"/>
              </a:ext>
            </a:extLst>
          </p:cNvPr>
          <p:cNvSpPr txBox="1"/>
          <p:nvPr/>
        </p:nvSpPr>
        <p:spPr>
          <a:xfrm>
            <a:off x="2179155" y="2712214"/>
            <a:ext cx="371302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c</a:t>
            </a:r>
            <a:endParaRPr lang="en-US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1D933E9-11BC-0C51-6EFF-7B9D7AF6EA0C}"/>
              </a:ext>
            </a:extLst>
          </p:cNvPr>
          <p:cNvSpPr txBox="1"/>
          <p:nvPr/>
        </p:nvSpPr>
        <p:spPr>
          <a:xfrm>
            <a:off x="8601694" y="2712214"/>
            <a:ext cx="371302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d</a:t>
            </a:r>
            <a:endParaRPr lang="en-US" dirty="0"/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FDDB84BC-85DF-1020-CC6D-52913D72DC94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b="18883"/>
          <a:stretch/>
        </p:blipFill>
        <p:spPr>
          <a:xfrm>
            <a:off x="1090346" y="3524928"/>
            <a:ext cx="1863359" cy="133438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17F1B663-6DB9-E9AF-A809-C0C36A68F421}"/>
              </a:ext>
            </a:extLst>
          </p:cNvPr>
          <p:cNvPicPr>
            <a:picLocks noChangeAspect="1"/>
          </p:cNvPicPr>
          <p:nvPr/>
        </p:nvPicPr>
        <p:blipFill>
          <a:blip r:embed="rId8">
            <a:lum bright="-5000" contrast="6000"/>
          </a:blip>
          <a:stretch>
            <a:fillRect/>
          </a:stretch>
        </p:blipFill>
        <p:spPr>
          <a:xfrm>
            <a:off x="3177824" y="3524928"/>
            <a:ext cx="1863358" cy="133438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4FE018C9-7CE0-777D-B327-CF534765632A}"/>
              </a:ext>
            </a:extLst>
          </p:cNvPr>
          <p:cNvSpPr txBox="1"/>
          <p:nvPr/>
        </p:nvSpPr>
        <p:spPr>
          <a:xfrm>
            <a:off x="4138078" y="1039695"/>
            <a:ext cx="107743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37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4ADF531-D316-CAF3-2717-201C86EB8BDF}"/>
              </a:ext>
            </a:extLst>
          </p:cNvPr>
          <p:cNvSpPr txBox="1"/>
          <p:nvPr/>
        </p:nvSpPr>
        <p:spPr>
          <a:xfrm>
            <a:off x="86113" y="1629359"/>
            <a:ext cx="107743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-</a:t>
            </a:r>
            <a:endParaRPr lang="en-US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F4FCDB4-BF4A-FCBD-59D3-D3932A63D05C}"/>
              </a:ext>
            </a:extLst>
          </p:cNvPr>
          <p:cNvSpPr txBox="1"/>
          <p:nvPr/>
        </p:nvSpPr>
        <p:spPr>
          <a:xfrm>
            <a:off x="10696023" y="960331"/>
            <a:ext cx="107743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37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6B82CF0-31A6-427F-3539-76334D1BC97B}"/>
              </a:ext>
            </a:extLst>
          </p:cNvPr>
          <p:cNvSpPr txBox="1"/>
          <p:nvPr/>
        </p:nvSpPr>
        <p:spPr>
          <a:xfrm>
            <a:off x="6696956" y="1692483"/>
            <a:ext cx="107743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-</a:t>
            </a:r>
            <a:endParaRPr lang="en-US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97450A7-B787-D4FE-AEFF-DFE03AFE4E46}"/>
              </a:ext>
            </a:extLst>
          </p:cNvPr>
          <p:cNvSpPr txBox="1"/>
          <p:nvPr/>
        </p:nvSpPr>
        <p:spPr>
          <a:xfrm>
            <a:off x="5018566" y="3693429"/>
            <a:ext cx="107743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37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478F8472-D925-C5A6-470F-F6EC9302AA9F}"/>
              </a:ext>
            </a:extLst>
          </p:cNvPr>
          <p:cNvSpPr txBox="1"/>
          <p:nvPr/>
        </p:nvSpPr>
        <p:spPr>
          <a:xfrm>
            <a:off x="142877" y="4466613"/>
            <a:ext cx="107743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57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-</a:t>
            </a:r>
            <a:endParaRPr lang="en-US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797A8F3-D086-BD3D-482C-F2A6A94550FE}"/>
              </a:ext>
            </a:extLst>
          </p:cNvPr>
          <p:cNvSpPr txBox="1"/>
          <p:nvPr/>
        </p:nvSpPr>
        <p:spPr>
          <a:xfrm>
            <a:off x="1635125" y="3148406"/>
            <a:ext cx="96713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g1</a:t>
            </a:r>
            <a:endParaRPr lang="en-US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28CBBF7E-A802-932F-3AC6-719EDC9F6910}"/>
              </a:ext>
            </a:extLst>
          </p:cNvPr>
          <p:cNvSpPr txBox="1"/>
          <p:nvPr/>
        </p:nvSpPr>
        <p:spPr>
          <a:xfrm>
            <a:off x="3599361" y="3127778"/>
            <a:ext cx="107743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en-US" dirty="0"/>
          </a:p>
        </p:txBody>
      </p:sp>
      <p:pic>
        <p:nvPicPr>
          <p:cNvPr id="32" name="Picture 31">
            <a:extLst>
              <a:ext uri="{FF2B5EF4-FFF2-40B4-BE49-F238E27FC236}">
                <a16:creationId xmlns:a16="http://schemas.microsoft.com/office/drawing/2014/main" id="{018EB0FF-CFB9-3CBD-9661-5F3DBC4C599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9333411" y="3395569"/>
            <a:ext cx="1863359" cy="140061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4" name="TextBox 33">
            <a:extLst>
              <a:ext uri="{FF2B5EF4-FFF2-40B4-BE49-F238E27FC236}">
                <a16:creationId xmlns:a16="http://schemas.microsoft.com/office/drawing/2014/main" id="{9E052DE2-2DA7-2602-72D2-9E8E38F003BF}"/>
              </a:ext>
            </a:extLst>
          </p:cNvPr>
          <p:cNvSpPr txBox="1"/>
          <p:nvPr/>
        </p:nvSpPr>
        <p:spPr>
          <a:xfrm>
            <a:off x="11186989" y="3407123"/>
            <a:ext cx="107743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37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264AECDB-8549-963F-4496-B314C0D5245F}"/>
              </a:ext>
            </a:extLst>
          </p:cNvPr>
          <p:cNvSpPr txBox="1"/>
          <p:nvPr/>
        </p:nvSpPr>
        <p:spPr>
          <a:xfrm>
            <a:off x="6281595" y="4406467"/>
            <a:ext cx="107743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57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-</a:t>
            </a:r>
            <a:endParaRPr lang="en-US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5C954547-F4D8-862B-AF58-0EE682C14429}"/>
              </a:ext>
            </a:extLst>
          </p:cNvPr>
          <p:cNvSpPr txBox="1"/>
          <p:nvPr/>
        </p:nvSpPr>
        <p:spPr>
          <a:xfrm>
            <a:off x="7773843" y="3002532"/>
            <a:ext cx="96713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g1</a:t>
            </a:r>
            <a:endParaRPr lang="en-US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2F2F1DF5-E27B-24F7-DC13-106CC828A140}"/>
              </a:ext>
            </a:extLst>
          </p:cNvPr>
          <p:cNvSpPr txBox="1"/>
          <p:nvPr/>
        </p:nvSpPr>
        <p:spPr>
          <a:xfrm>
            <a:off x="9738079" y="2981904"/>
            <a:ext cx="107743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en-US" dirty="0"/>
          </a:p>
        </p:txBody>
      </p:sp>
      <p:pic>
        <p:nvPicPr>
          <p:cNvPr id="38" name="Picture 37">
            <a:extLst>
              <a:ext uri="{FF2B5EF4-FFF2-40B4-BE49-F238E27FC236}">
                <a16:creationId xmlns:a16="http://schemas.microsoft.com/office/drawing/2014/main" id="{FE487EB1-34BF-0EE4-1C47-660DB3435241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287672" y="3395569"/>
            <a:ext cx="1863379" cy="1400762"/>
          </a:xfrm>
          <a:prstGeom prst="rect">
            <a:avLst/>
          </a:prstGeom>
          <a:ln w="9525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1903405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1</Words>
  <Application>Microsoft Macintosh PowerPoint</Application>
  <PresentationFormat>Widescreen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ran Madhar Rada</dc:creator>
  <cp:lastModifiedBy>Miran Madhar Rada</cp:lastModifiedBy>
  <cp:revision>1</cp:revision>
  <dcterms:created xsi:type="dcterms:W3CDTF">2022-07-21T05:19:05Z</dcterms:created>
  <dcterms:modified xsi:type="dcterms:W3CDTF">2022-07-21T05:20:48Z</dcterms:modified>
</cp:coreProperties>
</file>